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9"/>
  </p:normalViewPr>
  <p:slideViewPr>
    <p:cSldViewPr snapToGrid="0">
      <p:cViewPr>
        <p:scale>
          <a:sx n="83" d="100"/>
          <a:sy n="83" d="100"/>
        </p:scale>
        <p:origin x="1696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DA1E85-767C-0BCC-73A4-F9617F6398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2205BD-8319-9FC5-27B5-69488755B5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73F157-049A-EBB2-FAA1-6A359A7EE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432093-5FE1-98EB-486C-7485F834E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574643-E05B-2B01-3DE3-470535677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485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86122D-37B0-5F97-6EAA-877F2DAD7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8FDFEF-B5B0-2D5B-97C5-1A5F7EC7E1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3C126D-3AF0-7CEE-EF78-3688D1AED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65D21F-EA22-0AF7-7736-D2AF3AA22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D5D15-08EB-3AD4-9648-979F13D9A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337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AB3748-60C2-910E-E0E0-9988735BD0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B4316E-F06E-8C40-1783-4623EC9960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E779C2-C224-C35B-53CA-B56E9FA85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FF4ACC-BB35-0A88-B804-79D4C4D47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22F63-C652-4B4A-0787-9EC94D631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796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2849D-3718-50F9-F604-76A3C9B7DA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E986BC-9ED7-9EAB-143B-D2E687DB52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817290-F76B-1B89-8EEB-1DDA5D165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130BAB-2AA3-556C-82F9-D43F611DC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20B53-5E1D-619A-6A1F-CA462A210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86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FB2A6-D4F5-B221-D287-92CC56F75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97AC1C-8DFC-000C-B08B-5F00DD1F9C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611AE5-ADBC-FD73-B52E-8DBED250D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916BDE-34EF-0C0C-0886-AF85F0992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F71169-66C4-98FC-B7E9-03A23FFE4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785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066462-C117-C0D5-ED25-2897F47207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AF56C3-3D4E-E7A5-2DC3-C64CF069E2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2E08F6-3DD1-D294-2D1A-C4AB558E22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33F93C-D039-F487-507A-F6287112D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726AEE-91E3-6DE8-C8E8-7C74E2845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246E87-A703-DF24-94DA-485CEF8A2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082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319ED-39CA-CB0D-B11B-12E741D5F6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A41A20-9584-D2DD-D45F-62B577599D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C18700-8C6F-CA07-8F04-FA3DF4A0FF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0239B8-97CA-E368-05DC-D9A5ED2A17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A14AB1-918C-A775-C96F-67CAFBB5CC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7E1D3C-B334-7A21-A558-7EA7A9E96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871B24-827C-6EE5-620B-261735FE4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35D8E9-9C0B-27FA-BA17-D8F620241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515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2A9C7-F541-F2BA-F197-84CA147B0E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4AEC3B-1F3F-9567-CE89-7C4BAB7EE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E198FA-E31F-70A8-94FE-1F1BEEDD1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CA42F3-388F-B27E-B593-FDF921741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305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97254A-5698-3868-3F8D-3A9C04087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127123-4004-D00A-4254-BCE3F2A58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8D2838-5EA7-616D-6089-ED39DC1C5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66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7E0D34-414C-BD1B-84E5-B672F21CA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5DE30E-C6C1-6797-154E-A7AE911E88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394857-31B3-489C-BB52-E6B75F4026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BD19D-2358-8953-326C-6A57068FF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4647EC-4F01-A8D7-160C-DF72366A3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4D80F7-4C49-7DBD-1EDA-67249E7FC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665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567F8-B025-19DE-EE93-2C15AB7DE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994A04-3DE5-0B8D-187F-E685E99BA6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D08F9D-F519-F434-8EB4-FD2A2E1D04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F86AE1-AAE5-F5A7-E0AF-9915A09FF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65991A-1376-39CD-B80B-04226F2AA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594F42-6C61-C2F3-3588-3A05B95C9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58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81E6F5-8559-CF50-CA63-01C479C248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4DCBC9-4D47-EEFD-2CE1-8ABE80DB4F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EA43BD-946C-0B86-AE85-3634D6847A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E388E0-ECC4-7B49-8867-3040F1DBFB4D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74E85-037F-4DED-B638-265A6BA4B3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0643CC-F90A-E54A-D7DE-243D04C8DB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73452E3-75AA-4B42-B212-FB50B15CB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016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urry image of a person's face&#10;&#10;Description automatically generated">
            <a:extLst>
              <a:ext uri="{FF2B5EF4-FFF2-40B4-BE49-F238E27FC236}">
                <a16:creationId xmlns:a16="http://schemas.microsoft.com/office/drawing/2014/main" id="{521445D1-B19C-0680-9D56-50A1CD4541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372" y="1916842"/>
            <a:ext cx="5575300" cy="4457700"/>
          </a:xfrm>
          <a:prstGeom prst="rect">
            <a:avLst/>
          </a:prstGeom>
        </p:spPr>
      </p:pic>
      <p:pic>
        <p:nvPicPr>
          <p:cNvPr id="7" name="Picture 6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E169F621-40F1-CB0D-2935-24D52FA972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916842"/>
            <a:ext cx="5575300" cy="44577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318D4C3-3EF4-2B50-960E-8B0EAFBD24B2}"/>
              </a:ext>
            </a:extLst>
          </p:cNvPr>
          <p:cNvSpPr txBox="1"/>
          <p:nvPr/>
        </p:nvSpPr>
        <p:spPr>
          <a:xfrm>
            <a:off x="2469950" y="3511002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FAC7F4-F50A-4AB8-2953-D2DCA2D46971}"/>
              </a:ext>
            </a:extLst>
          </p:cNvPr>
          <p:cNvSpPr txBox="1"/>
          <p:nvPr/>
        </p:nvSpPr>
        <p:spPr>
          <a:xfrm>
            <a:off x="2469950" y="3721441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F94B0B7-7326-DB4D-3D2F-47197E4BE3FC}"/>
              </a:ext>
            </a:extLst>
          </p:cNvPr>
          <p:cNvSpPr txBox="1"/>
          <p:nvPr/>
        </p:nvSpPr>
        <p:spPr>
          <a:xfrm>
            <a:off x="2414785" y="3152001"/>
            <a:ext cx="976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39C45B-679C-EE53-5836-1A5BE4E7E070}"/>
              </a:ext>
            </a:extLst>
          </p:cNvPr>
          <p:cNvSpPr txBox="1"/>
          <p:nvPr/>
        </p:nvSpPr>
        <p:spPr>
          <a:xfrm>
            <a:off x="2469950" y="3884790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0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52839E7-E759-3A3E-1DC7-ED2CE2950994}"/>
              </a:ext>
            </a:extLst>
          </p:cNvPr>
          <p:cNvSpPr txBox="1"/>
          <p:nvPr/>
        </p:nvSpPr>
        <p:spPr>
          <a:xfrm>
            <a:off x="2469950" y="4083915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7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FFE718-5AAC-B64F-08FC-40FE9C19A8C3}"/>
              </a:ext>
            </a:extLst>
          </p:cNvPr>
          <p:cNvSpPr txBox="1"/>
          <p:nvPr/>
        </p:nvSpPr>
        <p:spPr>
          <a:xfrm rot="18900000">
            <a:off x="2668570" y="3240084"/>
            <a:ext cx="613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Vecto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0ECF735-E54B-9876-DD44-0CAB0AA80C6D}"/>
              </a:ext>
            </a:extLst>
          </p:cNvPr>
          <p:cNvSpPr txBox="1"/>
          <p:nvPr/>
        </p:nvSpPr>
        <p:spPr>
          <a:xfrm rot="18900000">
            <a:off x="2887326" y="3240083"/>
            <a:ext cx="613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eIF3k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08D9D9-AD10-8697-A327-9850F3B133D5}"/>
              </a:ext>
            </a:extLst>
          </p:cNvPr>
          <p:cNvSpPr txBox="1"/>
          <p:nvPr/>
        </p:nvSpPr>
        <p:spPr>
          <a:xfrm rot="18900000">
            <a:off x="3069561" y="3090098"/>
            <a:ext cx="1038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HAM+W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19364FB-C4A7-3A97-6CE1-EE741108BCE6}"/>
              </a:ext>
            </a:extLst>
          </p:cNvPr>
          <p:cNvSpPr txBox="1"/>
          <p:nvPr/>
        </p:nvSpPr>
        <p:spPr>
          <a:xfrm rot="18900000">
            <a:off x="3291202" y="3112900"/>
            <a:ext cx="1038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r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C1279F-3FE3-C02C-18DF-E8C2CAACB6E9}"/>
              </a:ext>
            </a:extLst>
          </p:cNvPr>
          <p:cNvSpPr txBox="1"/>
          <p:nvPr/>
        </p:nvSpPr>
        <p:spPr>
          <a:xfrm rot="18900000">
            <a:off x="3521803" y="3112899"/>
            <a:ext cx="1038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HA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9C5437-4C43-6318-3A78-9CE3E969FAE0}"/>
              </a:ext>
            </a:extLst>
          </p:cNvPr>
          <p:cNvSpPr txBox="1"/>
          <p:nvPr/>
        </p:nvSpPr>
        <p:spPr>
          <a:xfrm>
            <a:off x="3973590" y="3868471"/>
            <a:ext cx="164454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3xflag-eIF3k or eIF3k truncation mutan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206630A-3EC6-CAB9-D0A1-8A1CCF3A7A6E}"/>
              </a:ext>
            </a:extLst>
          </p:cNvPr>
          <p:cNvSpPr txBox="1"/>
          <p:nvPr/>
        </p:nvSpPr>
        <p:spPr>
          <a:xfrm>
            <a:off x="7690890" y="3787461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63</a:t>
            </a:r>
            <a:endParaRPr lang="en-US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F17CF4-08F6-5958-A212-B2874F80F719}"/>
              </a:ext>
            </a:extLst>
          </p:cNvPr>
          <p:cNvSpPr txBox="1"/>
          <p:nvPr/>
        </p:nvSpPr>
        <p:spPr>
          <a:xfrm>
            <a:off x="7645960" y="3290500"/>
            <a:ext cx="976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8F2E6AF-10C0-1195-999E-0D1BF2B118CF}"/>
              </a:ext>
            </a:extLst>
          </p:cNvPr>
          <p:cNvSpPr txBox="1"/>
          <p:nvPr/>
        </p:nvSpPr>
        <p:spPr>
          <a:xfrm>
            <a:off x="7696564" y="3998440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48</a:t>
            </a:r>
            <a:endParaRPr lang="en-US" sz="12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0AF2986-FB88-8356-AFAF-5E6D65F8D6C0}"/>
              </a:ext>
            </a:extLst>
          </p:cNvPr>
          <p:cNvSpPr txBox="1"/>
          <p:nvPr/>
        </p:nvSpPr>
        <p:spPr>
          <a:xfrm>
            <a:off x="7701125" y="4222414"/>
            <a:ext cx="437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</a:t>
            </a:r>
            <a:endParaRPr lang="en-US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82B1FFF-6265-CD11-DD46-71617827C98C}"/>
              </a:ext>
            </a:extLst>
          </p:cNvPr>
          <p:cNvSpPr txBox="1"/>
          <p:nvPr/>
        </p:nvSpPr>
        <p:spPr>
          <a:xfrm rot="18900000">
            <a:off x="7945366" y="3290627"/>
            <a:ext cx="613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Vecto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97D2BD-D8A1-F554-7467-09C3FEC4344E}"/>
              </a:ext>
            </a:extLst>
          </p:cNvPr>
          <p:cNvSpPr txBox="1"/>
          <p:nvPr/>
        </p:nvSpPr>
        <p:spPr>
          <a:xfrm rot="18900000">
            <a:off x="8164122" y="3290626"/>
            <a:ext cx="613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eIF3k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E0C7657-8674-0572-4FCA-676C0911C3F2}"/>
              </a:ext>
            </a:extLst>
          </p:cNvPr>
          <p:cNvSpPr txBox="1"/>
          <p:nvPr/>
        </p:nvSpPr>
        <p:spPr>
          <a:xfrm rot="18900000">
            <a:off x="8327697" y="3140641"/>
            <a:ext cx="1038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HAM+W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EC18FE7-E871-5335-A480-2A39B4E221A3}"/>
              </a:ext>
            </a:extLst>
          </p:cNvPr>
          <p:cNvSpPr txBox="1"/>
          <p:nvPr/>
        </p:nvSpPr>
        <p:spPr>
          <a:xfrm rot="18900000">
            <a:off x="8567998" y="3163443"/>
            <a:ext cx="1038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r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C57BA94-6214-6107-F70D-7A434379D785}"/>
              </a:ext>
            </a:extLst>
          </p:cNvPr>
          <p:cNvSpPr txBox="1"/>
          <p:nvPr/>
        </p:nvSpPr>
        <p:spPr>
          <a:xfrm rot="18900000">
            <a:off x="8761279" y="3163442"/>
            <a:ext cx="1038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HA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DB43FC1-90D1-D9FD-E680-4D7E1ED3F831}"/>
              </a:ext>
            </a:extLst>
          </p:cNvPr>
          <p:cNvSpPr txBox="1"/>
          <p:nvPr/>
        </p:nvSpPr>
        <p:spPr>
          <a:xfrm>
            <a:off x="9206763" y="3998440"/>
            <a:ext cx="1644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Symbol" pitchFamily="2" charset="2"/>
              </a:rPr>
              <a:t>b</a:t>
            </a:r>
            <a:r>
              <a:rPr lang="en-US" sz="1100" dirty="0"/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996563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9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de yao</dc:creator>
  <cp:lastModifiedBy>Jade yao</cp:lastModifiedBy>
  <cp:revision>1</cp:revision>
  <dcterms:created xsi:type="dcterms:W3CDTF">2024-07-09T07:10:35Z</dcterms:created>
  <dcterms:modified xsi:type="dcterms:W3CDTF">2024-07-09T07:35:54Z</dcterms:modified>
</cp:coreProperties>
</file>